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1" d="100"/>
          <a:sy n="61" d="100"/>
        </p:scale>
        <p:origin x="-1392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_1stshee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_1stshee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_1stshee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thhjb:Documents:DPhil_related:SWS_paper:revisions:Sleep%20structure_whole%20night_26SEP13_KA_SPSS_current_exclusions_P7added_spindles1_inclC1_1stshee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>
                <a:latin typeface="Arial"/>
                <a:cs typeface="Arial"/>
              </a:defRPr>
            </a:pPr>
            <a:r>
              <a:rPr lang="en-US">
                <a:latin typeface="Arial"/>
                <a:cs typeface="Arial"/>
              </a:rPr>
              <a:t>Twelve hours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Patients</c:v>
          </c:tx>
          <c:spPr>
            <a:ln w="47625">
              <a:noFill/>
            </a:ln>
            <a:effectLst/>
          </c:spPr>
          <c:marker>
            <c:symbol val="square"/>
            <c:size val="6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</c:marker>
          <c:xVal>
            <c:numRef>
              <c:f>Sheet11!$AA$14:$AA$24</c:f>
              <c:numCache>
                <c:formatCode>General</c:formatCode>
                <c:ptCount val="11"/>
                <c:pt idx="0">
                  <c:v>3.731617647058823</c:v>
                </c:pt>
                <c:pt idx="1">
                  <c:v>4.566112406767728</c:v>
                </c:pt>
                <c:pt idx="2">
                  <c:v>3.283029612756264</c:v>
                </c:pt>
                <c:pt idx="3">
                  <c:v>4.510645604395604</c:v>
                </c:pt>
                <c:pt idx="4">
                  <c:v>3.64754030846444</c:v>
                </c:pt>
                <c:pt idx="5">
                  <c:v>4.693877551020407</c:v>
                </c:pt>
                <c:pt idx="6">
                  <c:v>2.761075949367088</c:v>
                </c:pt>
                <c:pt idx="7">
                  <c:v>2.10560206052801</c:v>
                </c:pt>
                <c:pt idx="8">
                  <c:v>5.85</c:v>
                </c:pt>
                <c:pt idx="9">
                  <c:v>2.21283738287551</c:v>
                </c:pt>
                <c:pt idx="10">
                  <c:v>1.941850594227505</c:v>
                </c:pt>
              </c:numCache>
            </c:numRef>
          </c:xVal>
          <c:yVal>
            <c:numRef>
              <c:f>Sheet11!$AJ$14:$AJ$24</c:f>
              <c:numCache>
                <c:formatCode>General</c:formatCode>
                <c:ptCount val="11"/>
                <c:pt idx="0">
                  <c:v>3.0</c:v>
                </c:pt>
                <c:pt idx="1">
                  <c:v>6.0</c:v>
                </c:pt>
                <c:pt idx="2">
                  <c:v>3.0</c:v>
                </c:pt>
                <c:pt idx="3">
                  <c:v>10.0</c:v>
                </c:pt>
                <c:pt idx="4">
                  <c:v>1.0</c:v>
                </c:pt>
                <c:pt idx="5">
                  <c:v>0.0</c:v>
                </c:pt>
                <c:pt idx="6">
                  <c:v>1.0</c:v>
                </c:pt>
                <c:pt idx="7">
                  <c:v>-3.0</c:v>
                </c:pt>
                <c:pt idx="8">
                  <c:v>6.0</c:v>
                </c:pt>
                <c:pt idx="9">
                  <c:v>1.0</c:v>
                </c:pt>
                <c:pt idx="10">
                  <c:v>5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45720312"/>
        <c:axId val="-2145731912"/>
      </c:scatterChart>
      <c:valAx>
        <c:axId val="-21457203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Spindles per min in SWS</a:t>
                </a:r>
                <a:endParaRPr lang="en-US" sz="1000" dirty="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45731912"/>
        <c:crosses val="autoZero"/>
        <c:crossBetween val="midCat"/>
      </c:valAx>
      <c:valAx>
        <c:axId val="-21457319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>
                    <a:latin typeface="Arial"/>
                    <a:cs typeface="Arial"/>
                  </a:rPr>
                  <a:t>Sleep</a:t>
                </a:r>
                <a:r>
                  <a:rPr lang="en-US" sz="1000" baseline="0">
                    <a:latin typeface="Arial"/>
                    <a:cs typeface="Arial"/>
                  </a:rPr>
                  <a:t> benefit (pairs)</a:t>
                </a:r>
                <a:endParaRPr lang="en-US" sz="100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45720312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>
                <a:latin typeface="Arial"/>
                <a:cs typeface="Arial"/>
              </a:defRPr>
            </a:pPr>
            <a:r>
              <a:rPr lang="en-US">
                <a:latin typeface="Arial"/>
                <a:cs typeface="Arial"/>
              </a:rPr>
              <a:t>Twelve hours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s</c:v>
          </c:tx>
          <c:spPr>
            <a:ln w="47625">
              <a:noFill/>
            </a:ln>
            <a:effectLst/>
          </c:spPr>
          <c:marker>
            <c:symbol val="diamond"/>
            <c:size val="7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</c:marker>
          <c:xVal>
            <c:numRef>
              <c:f>Sheet11!$AA$2:$AA$13</c:f>
              <c:numCache>
                <c:formatCode>General</c:formatCode>
                <c:ptCount val="12"/>
                <c:pt idx="0">
                  <c:v>3.222300968580203</c:v>
                </c:pt>
                <c:pt idx="1">
                  <c:v>1.077922077922078</c:v>
                </c:pt>
                <c:pt idx="2">
                  <c:v>2.422498669781445</c:v>
                </c:pt>
                <c:pt idx="3">
                  <c:v>7.547196796338673</c:v>
                </c:pt>
                <c:pt idx="4">
                  <c:v>3.882189239332097</c:v>
                </c:pt>
                <c:pt idx="5">
                  <c:v>1.577494287890327</c:v>
                </c:pt>
                <c:pt idx="6">
                  <c:v>3.19395332390382</c:v>
                </c:pt>
                <c:pt idx="7">
                  <c:v>1.342988808426596</c:v>
                </c:pt>
                <c:pt idx="8">
                  <c:v>3.800531914893617</c:v>
                </c:pt>
                <c:pt idx="9">
                  <c:v>2.54067189770612</c:v>
                </c:pt>
                <c:pt idx="10">
                  <c:v>3.672449577861163</c:v>
                </c:pt>
                <c:pt idx="11">
                  <c:v>2.474804031354983</c:v>
                </c:pt>
              </c:numCache>
            </c:numRef>
          </c:xVal>
          <c:yVal>
            <c:numRef>
              <c:f>Sheet11!$AJ$2:$AJ$13</c:f>
              <c:numCache>
                <c:formatCode>General</c:formatCode>
                <c:ptCount val="12"/>
                <c:pt idx="0">
                  <c:v>7.0</c:v>
                </c:pt>
                <c:pt idx="1">
                  <c:v>3.0</c:v>
                </c:pt>
                <c:pt idx="2">
                  <c:v>3.0</c:v>
                </c:pt>
                <c:pt idx="3">
                  <c:v>2.0</c:v>
                </c:pt>
                <c:pt idx="4">
                  <c:v>3.0</c:v>
                </c:pt>
                <c:pt idx="5">
                  <c:v>4.0</c:v>
                </c:pt>
                <c:pt idx="6">
                  <c:v>5.0</c:v>
                </c:pt>
                <c:pt idx="7">
                  <c:v>1.0</c:v>
                </c:pt>
                <c:pt idx="8">
                  <c:v>4.0</c:v>
                </c:pt>
                <c:pt idx="9">
                  <c:v>5.0</c:v>
                </c:pt>
                <c:pt idx="10">
                  <c:v>-1.0</c:v>
                </c:pt>
                <c:pt idx="11">
                  <c:v>0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46600024"/>
        <c:axId val="-2146524536"/>
      </c:scatterChart>
      <c:valAx>
        <c:axId val="-21466000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Spindles per min in SWS</a:t>
                </a:r>
                <a:endParaRPr lang="en-US" sz="1000" dirty="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46524536"/>
        <c:crosses val="autoZero"/>
        <c:crossBetween val="midCat"/>
      </c:valAx>
      <c:valAx>
        <c:axId val="-2146524536"/>
        <c:scaling>
          <c:orientation val="minMax"/>
          <c:max val="15.0"/>
          <c:min val="-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>
                    <a:latin typeface="Arial"/>
                    <a:cs typeface="Arial"/>
                  </a:rPr>
                  <a:t>Sleep</a:t>
                </a:r>
                <a:r>
                  <a:rPr lang="en-US" sz="1000" baseline="0">
                    <a:latin typeface="Arial"/>
                    <a:cs typeface="Arial"/>
                  </a:rPr>
                  <a:t> benefit (pairs)</a:t>
                </a:r>
                <a:endParaRPr lang="en-US" sz="100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46600024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>
                <a:latin typeface="Arial"/>
                <a:cs typeface="Arial"/>
              </a:defRPr>
            </a:pPr>
            <a:r>
              <a:rPr lang="en-US">
                <a:latin typeface="Arial"/>
                <a:cs typeface="Arial"/>
              </a:rPr>
              <a:t>One week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1"/>
          <c:order val="0"/>
          <c:tx>
            <c:v>Patients</c:v>
          </c:tx>
          <c:spPr>
            <a:ln w="47625">
              <a:noFill/>
            </a:ln>
            <a:effectLst/>
          </c:spPr>
          <c:marker>
            <c:symbol val="square"/>
            <c:size val="6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  <a:effectLst/>
            </c:spPr>
          </c:marker>
          <c:xVal>
            <c:numRef>
              <c:f>Sheet11!$AA$14:$AA$24</c:f>
              <c:numCache>
                <c:formatCode>General</c:formatCode>
                <c:ptCount val="11"/>
                <c:pt idx="0">
                  <c:v>3.731617647058823</c:v>
                </c:pt>
                <c:pt idx="1">
                  <c:v>4.566112406767728</c:v>
                </c:pt>
                <c:pt idx="2">
                  <c:v>3.283029612756264</c:v>
                </c:pt>
                <c:pt idx="3">
                  <c:v>4.510645604395604</c:v>
                </c:pt>
                <c:pt idx="4">
                  <c:v>3.64754030846444</c:v>
                </c:pt>
                <c:pt idx="5">
                  <c:v>4.693877551020407</c:v>
                </c:pt>
                <c:pt idx="6">
                  <c:v>2.761075949367088</c:v>
                </c:pt>
                <c:pt idx="7">
                  <c:v>2.10560206052801</c:v>
                </c:pt>
                <c:pt idx="8">
                  <c:v>5.85</c:v>
                </c:pt>
                <c:pt idx="9">
                  <c:v>2.21283738287551</c:v>
                </c:pt>
                <c:pt idx="10">
                  <c:v>1.941850594227505</c:v>
                </c:pt>
              </c:numCache>
            </c:numRef>
          </c:xVal>
          <c:yVal>
            <c:numRef>
              <c:f>Sheet11!$AL$14:$AL$24</c:f>
              <c:numCache>
                <c:formatCode>General</c:formatCode>
                <c:ptCount val="11"/>
                <c:pt idx="0">
                  <c:v>-4.0</c:v>
                </c:pt>
                <c:pt idx="1">
                  <c:v>6.0</c:v>
                </c:pt>
                <c:pt idx="2">
                  <c:v>-2.0</c:v>
                </c:pt>
                <c:pt idx="3">
                  <c:v>8.0</c:v>
                </c:pt>
                <c:pt idx="4">
                  <c:v>2.0</c:v>
                </c:pt>
                <c:pt idx="5">
                  <c:v>-7.0</c:v>
                </c:pt>
                <c:pt idx="6">
                  <c:v>-3.0</c:v>
                </c:pt>
                <c:pt idx="7">
                  <c:v>-3.0</c:v>
                </c:pt>
                <c:pt idx="8">
                  <c:v>5.0</c:v>
                </c:pt>
                <c:pt idx="9">
                  <c:v>-1.0</c:v>
                </c:pt>
                <c:pt idx="10">
                  <c:v>1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37772024"/>
        <c:axId val="2101471464"/>
      </c:scatterChart>
      <c:valAx>
        <c:axId val="-21377720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Spindles per min in SWS</a:t>
                </a:r>
                <a:endParaRPr lang="en-US" sz="1000" dirty="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101471464"/>
        <c:crosses val="autoZero"/>
        <c:crossBetween val="midCat"/>
      </c:valAx>
      <c:valAx>
        <c:axId val="2101471464"/>
        <c:scaling>
          <c:orientation val="minMax"/>
          <c:max val="1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>
                    <a:latin typeface="Arial"/>
                    <a:cs typeface="Arial"/>
                  </a:rPr>
                  <a:t>Sleep benefit (pai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37772024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>
                <a:latin typeface="Arial"/>
                <a:cs typeface="Arial"/>
              </a:defRPr>
            </a:pPr>
            <a:r>
              <a:rPr lang="en-US">
                <a:latin typeface="Arial"/>
                <a:cs typeface="Arial"/>
              </a:rPr>
              <a:t>One week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Controls</c:v>
          </c:tx>
          <c:spPr>
            <a:ln w="47625">
              <a:noFill/>
            </a:ln>
            <a:effectLst/>
          </c:spPr>
          <c:marker>
            <c:symbol val="diamond"/>
            <c:size val="7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  <a:effectLst/>
            </c:spPr>
          </c:marker>
          <c:xVal>
            <c:numRef>
              <c:f>Sheet11!$AA$2:$AA$13</c:f>
              <c:numCache>
                <c:formatCode>General</c:formatCode>
                <c:ptCount val="12"/>
                <c:pt idx="0">
                  <c:v>3.222300968580203</c:v>
                </c:pt>
                <c:pt idx="1">
                  <c:v>1.077922077922078</c:v>
                </c:pt>
                <c:pt idx="2">
                  <c:v>2.422498669781445</c:v>
                </c:pt>
                <c:pt idx="3">
                  <c:v>7.547196796338673</c:v>
                </c:pt>
                <c:pt idx="4">
                  <c:v>3.882189239332097</c:v>
                </c:pt>
                <c:pt idx="5">
                  <c:v>1.577494287890327</c:v>
                </c:pt>
                <c:pt idx="6">
                  <c:v>3.19395332390382</c:v>
                </c:pt>
                <c:pt idx="7">
                  <c:v>1.342988808426596</c:v>
                </c:pt>
                <c:pt idx="8">
                  <c:v>3.800531914893617</c:v>
                </c:pt>
                <c:pt idx="9">
                  <c:v>2.54067189770612</c:v>
                </c:pt>
                <c:pt idx="10">
                  <c:v>3.672449577861163</c:v>
                </c:pt>
                <c:pt idx="11">
                  <c:v>2.474804031354983</c:v>
                </c:pt>
              </c:numCache>
            </c:numRef>
          </c:xVal>
          <c:yVal>
            <c:numRef>
              <c:f>Sheet11!$AL$2:$AL$13</c:f>
              <c:numCache>
                <c:formatCode>General</c:formatCode>
                <c:ptCount val="12"/>
                <c:pt idx="0">
                  <c:v>9.0</c:v>
                </c:pt>
                <c:pt idx="1">
                  <c:v>-6.0</c:v>
                </c:pt>
                <c:pt idx="2">
                  <c:v>0.0</c:v>
                </c:pt>
                <c:pt idx="3">
                  <c:v>5.0</c:v>
                </c:pt>
                <c:pt idx="4">
                  <c:v>-1.0</c:v>
                </c:pt>
                <c:pt idx="5">
                  <c:v>14.0</c:v>
                </c:pt>
                <c:pt idx="6">
                  <c:v>-2.0</c:v>
                </c:pt>
                <c:pt idx="7">
                  <c:v>5.0</c:v>
                </c:pt>
                <c:pt idx="8">
                  <c:v>1.0</c:v>
                </c:pt>
                <c:pt idx="9">
                  <c:v>7.0</c:v>
                </c:pt>
                <c:pt idx="10">
                  <c:v>-6.0</c:v>
                </c:pt>
                <c:pt idx="11">
                  <c:v>-5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37146696"/>
        <c:axId val="-2137425416"/>
      </c:scatterChart>
      <c:valAx>
        <c:axId val="-21371466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 dirty="0" smtClean="0">
                    <a:latin typeface="Arial"/>
                    <a:cs typeface="Arial"/>
                  </a:rPr>
                  <a:t>Spindles per min in SWS</a:t>
                </a:r>
                <a:endParaRPr lang="en-US" sz="1000" dirty="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37425416"/>
        <c:crosses val="autoZero"/>
        <c:crossBetween val="midCat"/>
      </c:valAx>
      <c:valAx>
        <c:axId val="-2137425416"/>
        <c:scaling>
          <c:orientation val="minMax"/>
          <c:max val="1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>
                    <a:latin typeface="Arial"/>
                    <a:cs typeface="Arial"/>
                  </a:defRPr>
                </a:pPr>
                <a:r>
                  <a:rPr lang="en-US" sz="1000">
                    <a:latin typeface="Arial"/>
                    <a:cs typeface="Arial"/>
                  </a:rPr>
                  <a:t>Sleep benefit (pai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37146696"/>
        <c:crosses val="autoZero"/>
        <c:crossBetween val="midCat"/>
      </c:valAx>
    </c:plotArea>
    <c:legend>
      <c:legendPos val="t"/>
      <c:layout/>
      <c:overlay val="0"/>
      <c:txPr>
        <a:bodyPr/>
        <a:lstStyle/>
        <a:p>
          <a:pPr>
            <a:defRPr sz="1200">
              <a:latin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600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688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944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490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357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205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011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179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273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526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695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E5AD1E-2944-C540-B7AE-02614D243E21}" type="datetimeFigureOut">
              <a:rPr lang="en-US" smtClean="0"/>
              <a:t>26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35B4E-BDBC-9F42-8691-E67ED2BAC3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135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0853131"/>
              </p:ext>
            </p:extLst>
          </p:nvPr>
        </p:nvGraphicFramePr>
        <p:xfrm>
          <a:off x="1143000" y="543349"/>
          <a:ext cx="2286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4143824"/>
              </p:ext>
            </p:extLst>
          </p:nvPr>
        </p:nvGraphicFramePr>
        <p:xfrm>
          <a:off x="3563696" y="543349"/>
          <a:ext cx="2286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2020194"/>
              </p:ext>
            </p:extLst>
          </p:nvPr>
        </p:nvGraphicFramePr>
        <p:xfrm>
          <a:off x="1277696" y="3435955"/>
          <a:ext cx="2286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15711"/>
              </p:ext>
            </p:extLst>
          </p:nvPr>
        </p:nvGraphicFramePr>
        <p:xfrm>
          <a:off x="3563696" y="3435955"/>
          <a:ext cx="2286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4037528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48</Words>
  <Application>Microsoft Macintosh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yn</dc:creator>
  <cp:lastModifiedBy>Kathryn</cp:lastModifiedBy>
  <cp:revision>7</cp:revision>
  <dcterms:created xsi:type="dcterms:W3CDTF">2016-02-23T10:51:08Z</dcterms:created>
  <dcterms:modified xsi:type="dcterms:W3CDTF">2016-06-26T21:23:58Z</dcterms:modified>
</cp:coreProperties>
</file>